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83" d="100"/>
          <a:sy n="83" d="100"/>
        </p:scale>
        <p:origin x="643" y="7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706516-583D-2A13-30E2-97995898278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0385F1CF-C1E8-B586-D562-84620C26C40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75BB097-1AD6-8E28-EF41-4EBB6BCCE0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280A5-FD62-49E3-9C33-2BB19D1224EB}" type="datetimeFigureOut">
              <a:rPr lang="en-CA" smtClean="0"/>
              <a:t>2023-07-2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9AFCF8-AEA1-5305-9106-C44DC90ED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82728C-089E-47CB-5945-B68FC209686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517A0-4E58-4741-985B-58B7E47C6E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740240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B10BB38-2F9C-CF20-9A12-A9C6DBC5D2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2D3495A-E967-3049-27A7-2274CE7883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4E83CF-D820-47BD-0116-CB72BC9CBC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280A5-FD62-49E3-9C33-2BB19D1224EB}" type="datetimeFigureOut">
              <a:rPr lang="en-CA" smtClean="0"/>
              <a:t>2023-07-2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62FD267-D8B9-C261-BF03-1D2703B9B1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7ACC827-DC09-5C3F-FEF1-C257294979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517A0-4E58-4741-985B-58B7E47C6E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667905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5C281EC-368B-82A8-4807-738155D42A0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5C8A1FC-68E5-2C10-5683-E8922360132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367B835-5D36-7B91-8F40-137C6D2992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280A5-FD62-49E3-9C33-2BB19D1224EB}" type="datetimeFigureOut">
              <a:rPr lang="en-CA" smtClean="0"/>
              <a:t>2023-07-2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FF213D5-1DB9-B2DE-3832-CF0F8EDA0A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7C03EE8-2C5A-F455-DF6A-5BFCBFF5CD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517A0-4E58-4741-985B-58B7E47C6E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1797517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0038D8-416C-3226-D78A-F5AFB6F3E35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49B825-AB3A-D52F-DC68-A6119D7D681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D60C8AB-9535-A5AB-7467-8A6E30BA6C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280A5-FD62-49E3-9C33-2BB19D1224EB}" type="datetimeFigureOut">
              <a:rPr lang="en-CA" smtClean="0"/>
              <a:t>2023-07-2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F826737-1850-FC73-308F-E492016829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BED427-D314-2588-4CA2-750A70C353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517A0-4E58-4741-985B-58B7E47C6E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9778570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943E86E-4705-3CED-09A6-351D7041A42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BA0A21-DCD1-6079-24FD-26A58081C4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7A8215-0731-97C3-1CC2-6C436D2467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280A5-FD62-49E3-9C33-2BB19D1224EB}" type="datetimeFigureOut">
              <a:rPr lang="en-CA" smtClean="0"/>
              <a:t>2023-07-2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C58BC72-694C-8234-3C66-E5B09C1EC2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FBB991-18EF-3E68-318D-70E7D4028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517A0-4E58-4741-985B-58B7E47C6E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2146830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21C754-7B81-0D20-615E-7084B6615AB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1DCD305-6225-657B-501F-B9A5E6316A3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8956B0C-EC7F-0AAD-6FFE-B132DB0A0AF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E6596D8-6A75-86FD-39D7-D7251D6482F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280A5-FD62-49E3-9C33-2BB19D1224EB}" type="datetimeFigureOut">
              <a:rPr lang="en-CA" smtClean="0"/>
              <a:t>2023-07-23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EE1B93B-FB23-0AED-E528-B99B1353EC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165868-1EF7-DDA6-A4A2-79D788E201A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517A0-4E58-4741-985B-58B7E47C6E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78825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11E89A2-AE19-DF3C-9320-2ACDB077CE4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A02C060-8531-84B3-E3A9-80184D81FE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AB17125-8500-7EFB-9624-2C1D7F5749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9D7E702-E597-D07A-FF6E-358B1D1EF4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E27F33B0-7310-A5B4-53A0-8B5BF42D223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03CD1F7-10CE-2749-BBBD-FE5BD0915E3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280A5-FD62-49E3-9C33-2BB19D1224EB}" type="datetimeFigureOut">
              <a:rPr lang="en-CA" smtClean="0"/>
              <a:t>2023-07-23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F06C20F-A5B7-6804-6733-825AB6964C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354E3ED-9DD8-7471-63BD-8D7ACB3CE2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517A0-4E58-4741-985B-58B7E47C6E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66003898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BBE1DCC-50EE-EC95-219E-A95221EF0BF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E8760A87-7CCA-A654-8946-7372D7F0EE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280A5-FD62-49E3-9C33-2BB19D1224EB}" type="datetimeFigureOut">
              <a:rPr lang="en-CA" smtClean="0"/>
              <a:t>2023-07-23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6BE2CD9-D950-4D84-A9E8-7A87A270F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E34BF681-0868-2EC3-CF34-DD2D25BC362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517A0-4E58-4741-985B-58B7E47C6E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1090474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72C8AFE-24BE-4FD9-0FF6-052B56AB3D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280A5-FD62-49E3-9C33-2BB19D1224EB}" type="datetimeFigureOut">
              <a:rPr lang="en-CA" smtClean="0"/>
              <a:t>2023-07-23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67BCA0F-1933-7869-A712-55065AEB3E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21755CF-6BA5-43C1-234D-361CE03E7B8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517A0-4E58-4741-985B-58B7E47C6E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122494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5FCB921-0B0E-6172-0BE6-123A2EF2A1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78CEFAB-D90A-C6DC-B60A-5AC3EF7B23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5A63B14-3313-8458-A1DA-DD654E93DB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15AB0B0-6278-C7D1-51F6-BB5B3A55F0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280A5-FD62-49E3-9C33-2BB19D1224EB}" type="datetimeFigureOut">
              <a:rPr lang="en-CA" smtClean="0"/>
              <a:t>2023-07-23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EB294D-6C0F-B2C5-440A-27BD88F1B2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A9943FC-158F-EDEF-3F97-EF67C0F733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517A0-4E58-4741-985B-58B7E47C6E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9381192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85640C-0948-D44F-FF72-3710B8C659C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FAA3209-ACA1-156E-C3B2-2ECB60EB040E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4D850E6-0ABA-32B4-89A8-9C1807244FB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6D75EC4-98D8-C7C5-1D8A-698D9AEC82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61280A5-FD62-49E3-9C33-2BB19D1224EB}" type="datetimeFigureOut">
              <a:rPr lang="en-CA" smtClean="0"/>
              <a:t>2023-07-23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B813A69-4E9F-50CD-ACD5-4F15F81840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F4FCCBB-D745-2807-9EBB-8B0FC3ECF5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69517A0-4E58-4741-985B-58B7E47C6E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07062369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7F577C6-F357-F6E5-1771-C0E06AF0CD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D4117E6-C600-D0B5-7FFC-4799C315593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B0C2289-0D49-FA4C-C8DF-8D253D75157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61280A5-FD62-49E3-9C33-2BB19D1224EB}" type="datetimeFigureOut">
              <a:rPr lang="en-CA" smtClean="0"/>
              <a:t>2023-07-23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AB0211-1B10-09A3-83AE-47931D31422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C1761D-1572-B136-C7AE-0C5DB58A64D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69517A0-4E58-4741-985B-58B7E47C6EE2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4091010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>
            <a:extLst>
              <a:ext uri="{FF2B5EF4-FFF2-40B4-BE49-F238E27FC236}">
                <a16:creationId xmlns:a16="http://schemas.microsoft.com/office/drawing/2014/main" id="{1E318FB1-8F95-5DE0-BBD3-9E8C93A516C3}"/>
              </a:ext>
            </a:extLst>
          </p:cNvPr>
          <p:cNvSpPr txBox="1"/>
          <p:nvPr/>
        </p:nvSpPr>
        <p:spPr>
          <a:xfrm>
            <a:off x="154315" y="2731078"/>
            <a:ext cx="7185823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: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 overview of clinical and artificial DNA included in the NGS based chimerism validation process (Clinical samples, Artificial construct samples and ASHI EMO Proficiency samples)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Rectangle: Rounded Corners 2">
            <a:extLst>
              <a:ext uri="{FF2B5EF4-FFF2-40B4-BE49-F238E27FC236}">
                <a16:creationId xmlns:a16="http://schemas.microsoft.com/office/drawing/2014/main" id="{24ED90AF-C5B8-7067-8F38-FECE6243CBC7}"/>
              </a:ext>
            </a:extLst>
          </p:cNvPr>
          <p:cNvSpPr/>
          <p:nvPr/>
        </p:nvSpPr>
        <p:spPr>
          <a:xfrm>
            <a:off x="1369706" y="1005794"/>
            <a:ext cx="1005840" cy="548640"/>
          </a:xfrm>
          <a:prstGeom prst="round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 transplant Clinical DNA (n=138)</a:t>
            </a:r>
          </a:p>
        </p:txBody>
      </p:sp>
      <p:sp>
        <p:nvSpPr>
          <p:cNvPr id="4" name="Rectangle: Rounded Corners 3">
            <a:extLst>
              <a:ext uri="{FF2B5EF4-FFF2-40B4-BE49-F238E27FC236}">
                <a16:creationId xmlns:a16="http://schemas.microsoft.com/office/drawing/2014/main" id="{773D4290-2E9F-CFA0-7476-C92204B4AAEB}"/>
              </a:ext>
            </a:extLst>
          </p:cNvPr>
          <p:cNvSpPr/>
          <p:nvPr/>
        </p:nvSpPr>
        <p:spPr>
          <a:xfrm>
            <a:off x="327399" y="1966644"/>
            <a:ext cx="1005840" cy="548640"/>
          </a:xfrm>
          <a:prstGeom prst="round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 transplant Donor DNA (n=46)</a:t>
            </a:r>
          </a:p>
        </p:txBody>
      </p:sp>
      <p:sp>
        <p:nvSpPr>
          <p:cNvPr id="5" name="Rectangle: Rounded Corners 4">
            <a:extLst>
              <a:ext uri="{FF2B5EF4-FFF2-40B4-BE49-F238E27FC236}">
                <a16:creationId xmlns:a16="http://schemas.microsoft.com/office/drawing/2014/main" id="{C2FDB86E-603E-DCB9-3AB1-CCB5C36A5CC1}"/>
              </a:ext>
            </a:extLst>
          </p:cNvPr>
          <p:cNvSpPr/>
          <p:nvPr/>
        </p:nvSpPr>
        <p:spPr>
          <a:xfrm>
            <a:off x="1409120" y="1966644"/>
            <a:ext cx="1005840" cy="548640"/>
          </a:xfrm>
          <a:prstGeom prst="round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e transplant Recipient DNA (n=46)</a:t>
            </a:r>
          </a:p>
        </p:txBody>
      </p:sp>
      <p:sp>
        <p:nvSpPr>
          <p:cNvPr id="6" name="Rectangle: Rounded Corners 5">
            <a:extLst>
              <a:ext uri="{FF2B5EF4-FFF2-40B4-BE49-F238E27FC236}">
                <a16:creationId xmlns:a16="http://schemas.microsoft.com/office/drawing/2014/main" id="{95BA8BDC-4734-577B-AA07-7E8815ADFDD8}"/>
              </a:ext>
            </a:extLst>
          </p:cNvPr>
          <p:cNvSpPr/>
          <p:nvPr/>
        </p:nvSpPr>
        <p:spPr>
          <a:xfrm>
            <a:off x="2470986" y="1962605"/>
            <a:ext cx="1005840" cy="548640"/>
          </a:xfrm>
          <a:prstGeom prst="roundRect">
            <a:avLst/>
          </a:prstGeom>
          <a:solidFill>
            <a:schemeClr val="accent3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ost-transplant Recipient DNA (n=46)</a:t>
            </a:r>
          </a:p>
        </p:txBody>
      </p:sp>
      <p:sp>
        <p:nvSpPr>
          <p:cNvPr id="8" name="Rectangle: Rounded Corners 7">
            <a:extLst>
              <a:ext uri="{FF2B5EF4-FFF2-40B4-BE49-F238E27FC236}">
                <a16:creationId xmlns:a16="http://schemas.microsoft.com/office/drawing/2014/main" id="{957DCC24-A3EE-1B77-FC8E-ED0316060F6B}"/>
              </a:ext>
            </a:extLst>
          </p:cNvPr>
          <p:cNvSpPr/>
          <p:nvPr/>
        </p:nvSpPr>
        <p:spPr>
          <a:xfrm>
            <a:off x="4243256" y="1032429"/>
            <a:ext cx="1005840" cy="548640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rtificial gDNA (n=36)</a:t>
            </a:r>
          </a:p>
        </p:txBody>
      </p:sp>
      <p:sp>
        <p:nvSpPr>
          <p:cNvPr id="9" name="Rectangle: Rounded Corners 8">
            <a:extLst>
              <a:ext uri="{FF2B5EF4-FFF2-40B4-BE49-F238E27FC236}">
                <a16:creationId xmlns:a16="http://schemas.microsoft.com/office/drawing/2014/main" id="{ACED9F65-362C-2D94-C9D0-26E78EBFB4EA}"/>
              </a:ext>
            </a:extLst>
          </p:cNvPr>
          <p:cNvSpPr/>
          <p:nvPr/>
        </p:nvSpPr>
        <p:spPr>
          <a:xfrm>
            <a:off x="3703048" y="1966644"/>
            <a:ext cx="1005840" cy="548640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imulated chimerism (n=24)</a:t>
            </a:r>
          </a:p>
        </p:txBody>
      </p:sp>
      <p:sp>
        <p:nvSpPr>
          <p:cNvPr id="10" name="Rectangle: Rounded Corners 9">
            <a:extLst>
              <a:ext uri="{FF2B5EF4-FFF2-40B4-BE49-F238E27FC236}">
                <a16:creationId xmlns:a16="http://schemas.microsoft.com/office/drawing/2014/main" id="{060D44A8-3153-B33E-06BB-F5449A63BAE8}"/>
              </a:ext>
            </a:extLst>
          </p:cNvPr>
          <p:cNvSpPr/>
          <p:nvPr/>
        </p:nvSpPr>
        <p:spPr>
          <a:xfrm>
            <a:off x="4782251" y="1962979"/>
            <a:ext cx="1005840" cy="548640"/>
          </a:xfrm>
          <a:prstGeom prst="round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erial Dilutions (n=12)</a:t>
            </a:r>
          </a:p>
        </p:txBody>
      </p:sp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6C2D3B29-6179-DF10-8DB6-B2541B24F3C7}"/>
              </a:ext>
            </a:extLst>
          </p:cNvPr>
          <p:cNvSpPr/>
          <p:nvPr/>
        </p:nvSpPr>
        <p:spPr>
          <a:xfrm>
            <a:off x="6031744" y="1969888"/>
            <a:ext cx="1005840" cy="548640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SHI-EMO program (n=10)</a:t>
            </a:r>
          </a:p>
        </p:txBody>
      </p:sp>
      <p:grpSp>
        <p:nvGrpSpPr>
          <p:cNvPr id="22" name="Group 21">
            <a:extLst>
              <a:ext uri="{FF2B5EF4-FFF2-40B4-BE49-F238E27FC236}">
                <a16:creationId xmlns:a16="http://schemas.microsoft.com/office/drawing/2014/main" id="{72DA5CCA-D1C1-3435-A066-4B003CEE10F2}"/>
              </a:ext>
            </a:extLst>
          </p:cNvPr>
          <p:cNvGrpSpPr/>
          <p:nvPr/>
        </p:nvGrpSpPr>
        <p:grpSpPr>
          <a:xfrm>
            <a:off x="830319" y="1554435"/>
            <a:ext cx="2163443" cy="396478"/>
            <a:chOff x="914400" y="1985301"/>
            <a:chExt cx="2971800" cy="396478"/>
          </a:xfrm>
          <a:solidFill>
            <a:schemeClr val="accent1">
              <a:lumMod val="20000"/>
              <a:lumOff val="80000"/>
            </a:schemeClr>
          </a:solidFill>
        </p:grpSpPr>
        <p:cxnSp>
          <p:nvCxnSpPr>
            <p:cNvPr id="13" name="Straight Connector 12">
              <a:extLst>
                <a:ext uri="{FF2B5EF4-FFF2-40B4-BE49-F238E27FC236}">
                  <a16:creationId xmlns:a16="http://schemas.microsoft.com/office/drawing/2014/main" id="{AA5F83F0-49AA-77D9-D666-61362939B636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346158" y="1985301"/>
              <a:ext cx="0" cy="208089"/>
            </a:xfrm>
            <a:prstGeom prst="line">
              <a:avLst/>
            </a:prstGeom>
            <a:grpFill/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Straight Connector 14">
              <a:extLst>
                <a:ext uri="{FF2B5EF4-FFF2-40B4-BE49-F238E27FC236}">
                  <a16:creationId xmlns:a16="http://schemas.microsoft.com/office/drawing/2014/main" id="{E90092D5-6EF5-9799-6A30-91A3EC847634}"/>
                </a:ext>
              </a:extLst>
            </p:cNvPr>
            <p:cNvCxnSpPr/>
            <p:nvPr/>
          </p:nvCxnSpPr>
          <p:spPr>
            <a:xfrm>
              <a:off x="914400" y="2201779"/>
              <a:ext cx="2971800" cy="0"/>
            </a:xfrm>
            <a:prstGeom prst="line">
              <a:avLst/>
            </a:prstGeom>
            <a:grpFill/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Arrow Connector 17">
              <a:extLst>
                <a:ext uri="{FF2B5EF4-FFF2-40B4-BE49-F238E27FC236}">
                  <a16:creationId xmlns:a16="http://schemas.microsoft.com/office/drawing/2014/main" id="{A136FAB4-919D-6531-3160-B532B051FB5D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916543" y="2201779"/>
              <a:ext cx="0" cy="180000"/>
            </a:xfrm>
            <a:prstGeom prst="straightConnector1">
              <a:avLst/>
            </a:prstGeom>
            <a:grpFill/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Arrow Connector 19">
              <a:extLst>
                <a:ext uri="{FF2B5EF4-FFF2-40B4-BE49-F238E27FC236}">
                  <a16:creationId xmlns:a16="http://schemas.microsoft.com/office/drawing/2014/main" id="{801AA71A-77DA-047E-8FB1-91EBB751FE5A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2349699" y="2201779"/>
              <a:ext cx="0" cy="180000"/>
            </a:xfrm>
            <a:prstGeom prst="straightConnector1">
              <a:avLst/>
            </a:prstGeom>
            <a:grpFill/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Arrow Connector 20">
              <a:extLst>
                <a:ext uri="{FF2B5EF4-FFF2-40B4-BE49-F238E27FC236}">
                  <a16:creationId xmlns:a16="http://schemas.microsoft.com/office/drawing/2014/main" id="{F9097E44-9E41-9373-D778-8526F0C5D888}"/>
                </a:ext>
              </a:extLst>
            </p:cNvPr>
            <p:cNvCxnSpPr>
              <a:cxnSpLocks/>
            </p:cNvCxnSpPr>
            <p:nvPr/>
          </p:nvCxnSpPr>
          <p:spPr>
            <a:xfrm flipH="1">
              <a:off x="3886200" y="2201779"/>
              <a:ext cx="0" cy="180000"/>
            </a:xfrm>
            <a:prstGeom prst="straightConnector1">
              <a:avLst/>
            </a:prstGeom>
            <a:grpFill/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0847F5D4-0674-D7FB-728E-95219E4CDB8F}"/>
              </a:ext>
            </a:extLst>
          </p:cNvPr>
          <p:cNvCxnSpPr>
            <a:cxnSpLocks/>
          </p:cNvCxnSpPr>
          <p:nvPr/>
        </p:nvCxnSpPr>
        <p:spPr>
          <a:xfrm flipH="1">
            <a:off x="4737863" y="1585820"/>
            <a:ext cx="0" cy="2080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Straight Connector 24">
            <a:extLst>
              <a:ext uri="{FF2B5EF4-FFF2-40B4-BE49-F238E27FC236}">
                <a16:creationId xmlns:a16="http://schemas.microsoft.com/office/drawing/2014/main" id="{0DEC6E8C-934A-7C62-7067-A7E7945CA18F}"/>
              </a:ext>
            </a:extLst>
          </p:cNvPr>
          <p:cNvCxnSpPr/>
          <p:nvPr/>
        </p:nvCxnSpPr>
        <p:spPr>
          <a:xfrm flipV="1">
            <a:off x="4212584" y="1785520"/>
            <a:ext cx="1067184" cy="8389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Arrow Connector 25">
            <a:extLst>
              <a:ext uri="{FF2B5EF4-FFF2-40B4-BE49-F238E27FC236}">
                <a16:creationId xmlns:a16="http://schemas.microsoft.com/office/drawing/2014/main" id="{7111664E-AAD3-885F-62FC-158D17FD91FF}"/>
              </a:ext>
            </a:extLst>
          </p:cNvPr>
          <p:cNvCxnSpPr>
            <a:cxnSpLocks/>
          </p:cNvCxnSpPr>
          <p:nvPr/>
        </p:nvCxnSpPr>
        <p:spPr>
          <a:xfrm flipH="1">
            <a:off x="4214181" y="1793909"/>
            <a:ext cx="0" cy="1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Straight Arrow Connector 26">
            <a:extLst>
              <a:ext uri="{FF2B5EF4-FFF2-40B4-BE49-F238E27FC236}">
                <a16:creationId xmlns:a16="http://schemas.microsoft.com/office/drawing/2014/main" id="{34A7FB84-31B3-6DF5-7A77-3A8DC1193B98}"/>
              </a:ext>
            </a:extLst>
          </p:cNvPr>
          <p:cNvCxnSpPr>
            <a:cxnSpLocks/>
          </p:cNvCxnSpPr>
          <p:nvPr/>
        </p:nvCxnSpPr>
        <p:spPr>
          <a:xfrm flipH="1">
            <a:off x="5282407" y="1793909"/>
            <a:ext cx="0" cy="180000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Straight Arrow Connector 27">
            <a:extLst>
              <a:ext uri="{FF2B5EF4-FFF2-40B4-BE49-F238E27FC236}">
                <a16:creationId xmlns:a16="http://schemas.microsoft.com/office/drawing/2014/main" id="{C5F680D2-D563-96EB-FFEB-DEC162AB753C}"/>
              </a:ext>
            </a:extLst>
          </p:cNvPr>
          <p:cNvCxnSpPr>
            <a:cxnSpLocks/>
            <a:stCxn id="71" idx="2"/>
          </p:cNvCxnSpPr>
          <p:nvPr/>
        </p:nvCxnSpPr>
        <p:spPr>
          <a:xfrm>
            <a:off x="6534664" y="1575624"/>
            <a:ext cx="0" cy="398285"/>
          </a:xfrm>
          <a:prstGeom prst="straightConnector1">
            <a:avLst/>
          </a:prstGeom>
          <a:ln w="190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2" name="TextBox 51">
            <a:extLst>
              <a:ext uri="{FF2B5EF4-FFF2-40B4-BE49-F238E27FC236}">
                <a16:creationId xmlns:a16="http://schemas.microsoft.com/office/drawing/2014/main" id="{1E318FB1-8F95-5DE0-BBD3-9E8C93A516C3}"/>
              </a:ext>
            </a:extLst>
          </p:cNvPr>
          <p:cNvSpPr txBox="1"/>
          <p:nvPr/>
        </p:nvSpPr>
        <p:spPr>
          <a:xfrm>
            <a:off x="150084" y="6317615"/>
            <a:ext cx="70857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b: </a:t>
            </a:r>
            <a:r>
              <a:rPr lang="en-CA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chematic presentation of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time required for the NG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merism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ssay</a:t>
            </a:r>
            <a:endParaRPr lang="en-CA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69" name="Group 68"/>
          <p:cNvGrpSpPr/>
          <p:nvPr/>
        </p:nvGrpSpPr>
        <p:grpSpPr>
          <a:xfrm>
            <a:off x="225594" y="4010293"/>
            <a:ext cx="7022230" cy="2161225"/>
            <a:chOff x="143339" y="3686321"/>
            <a:chExt cx="7306416" cy="2161225"/>
          </a:xfrm>
        </p:grpSpPr>
        <p:grpSp>
          <p:nvGrpSpPr>
            <p:cNvPr id="16" name="Group 15"/>
            <p:cNvGrpSpPr/>
            <p:nvPr/>
          </p:nvGrpSpPr>
          <p:grpSpPr>
            <a:xfrm>
              <a:off x="143339" y="4054867"/>
              <a:ext cx="1441554" cy="1429789"/>
              <a:chOff x="1583961" y="4206239"/>
              <a:chExt cx="1441554" cy="1429789"/>
            </a:xfrm>
            <a:solidFill>
              <a:schemeClr val="accent5">
                <a:lumMod val="60000"/>
                <a:lumOff val="40000"/>
              </a:schemeClr>
            </a:solidFill>
          </p:grpSpPr>
          <p:sp>
            <p:nvSpPr>
              <p:cNvPr id="7" name="Right Arrow 6"/>
              <p:cNvSpPr/>
              <p:nvPr/>
            </p:nvSpPr>
            <p:spPr>
              <a:xfrm>
                <a:off x="1583961" y="4206239"/>
                <a:ext cx="1441554" cy="1429789"/>
              </a:xfrm>
              <a:prstGeom prst="rightArrow">
                <a:avLst/>
              </a:prstGeom>
              <a:solidFill>
                <a:schemeClr val="bg1">
                  <a:lumMod val="75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13"/>
              <p:cNvSpPr txBox="1"/>
              <p:nvPr/>
            </p:nvSpPr>
            <p:spPr>
              <a:xfrm>
                <a:off x="1583961" y="4579953"/>
                <a:ext cx="1042861" cy="55399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NA Extraction from blood and bone marrow</a:t>
                </a:r>
              </a:p>
            </p:txBody>
          </p:sp>
        </p:grpSp>
        <p:grpSp>
          <p:nvGrpSpPr>
            <p:cNvPr id="31" name="Group 30"/>
            <p:cNvGrpSpPr/>
            <p:nvPr/>
          </p:nvGrpSpPr>
          <p:grpSpPr>
            <a:xfrm>
              <a:off x="1600076" y="4054866"/>
              <a:ext cx="1451310" cy="1429789"/>
              <a:chOff x="1574205" y="4206239"/>
              <a:chExt cx="1451310" cy="1429789"/>
            </a:xfrm>
            <a:solidFill>
              <a:schemeClr val="accent2">
                <a:lumMod val="40000"/>
                <a:lumOff val="60000"/>
              </a:schemeClr>
            </a:solidFill>
          </p:grpSpPr>
          <p:sp>
            <p:nvSpPr>
              <p:cNvPr id="32" name="Right Arrow 31"/>
              <p:cNvSpPr/>
              <p:nvPr/>
            </p:nvSpPr>
            <p:spPr>
              <a:xfrm>
                <a:off x="1583961" y="4206239"/>
                <a:ext cx="1441554" cy="1429789"/>
              </a:xfrm>
              <a:prstGeom prst="rightArrow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3" name="TextBox 32"/>
              <p:cNvSpPr txBox="1"/>
              <p:nvPr/>
            </p:nvSpPr>
            <p:spPr>
              <a:xfrm>
                <a:off x="1574205" y="4561002"/>
                <a:ext cx="1317613" cy="70788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ibrary preparation: PCR amplification, Tagmentation and Enrichment (indexing and barcoding)</a:t>
                </a:r>
              </a:p>
            </p:txBody>
          </p:sp>
        </p:grpSp>
        <p:grpSp>
          <p:nvGrpSpPr>
            <p:cNvPr id="34" name="Group 33"/>
            <p:cNvGrpSpPr/>
            <p:nvPr/>
          </p:nvGrpSpPr>
          <p:grpSpPr>
            <a:xfrm>
              <a:off x="3076325" y="4054866"/>
              <a:ext cx="1605817" cy="1429789"/>
              <a:chOff x="1583961" y="4206239"/>
              <a:chExt cx="1605817" cy="1429789"/>
            </a:xfrm>
            <a:solidFill>
              <a:schemeClr val="accent2">
                <a:lumMod val="40000"/>
                <a:lumOff val="60000"/>
              </a:schemeClr>
            </a:solidFill>
          </p:grpSpPr>
          <p:sp>
            <p:nvSpPr>
              <p:cNvPr id="35" name="Right Arrow 34"/>
              <p:cNvSpPr/>
              <p:nvPr/>
            </p:nvSpPr>
            <p:spPr>
              <a:xfrm>
                <a:off x="1583961" y="4206239"/>
                <a:ext cx="1441554" cy="1429789"/>
              </a:xfrm>
              <a:prstGeom prst="rightArrow">
                <a:avLst/>
              </a:prstGeom>
              <a:solidFill>
                <a:schemeClr val="accent4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6" name="TextBox 35"/>
              <p:cNvSpPr txBox="1"/>
              <p:nvPr/>
            </p:nvSpPr>
            <p:spPr>
              <a:xfrm>
                <a:off x="1600584" y="4631765"/>
                <a:ext cx="1589194" cy="584775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8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ibrary Purification, normalization and pooling. Denaturation and dilution at loading concentration</a:t>
                </a:r>
              </a:p>
            </p:txBody>
          </p:sp>
        </p:grpSp>
        <p:grpSp>
          <p:nvGrpSpPr>
            <p:cNvPr id="37" name="Group 36"/>
            <p:cNvGrpSpPr/>
            <p:nvPr/>
          </p:nvGrpSpPr>
          <p:grpSpPr>
            <a:xfrm>
              <a:off x="4542386" y="4054864"/>
              <a:ext cx="1441554" cy="1429789"/>
              <a:chOff x="1583961" y="4206239"/>
              <a:chExt cx="1441554" cy="1429789"/>
            </a:xfrm>
          </p:grpSpPr>
          <p:sp>
            <p:nvSpPr>
              <p:cNvPr id="38" name="Right Arrow 37"/>
              <p:cNvSpPr/>
              <p:nvPr/>
            </p:nvSpPr>
            <p:spPr>
              <a:xfrm>
                <a:off x="1583961" y="4206239"/>
                <a:ext cx="1441554" cy="1429789"/>
              </a:xfrm>
              <a:prstGeom prst="rightArrow">
                <a:avLst/>
              </a:prstGeom>
              <a:solidFill>
                <a:schemeClr val="accent6">
                  <a:lumMod val="60000"/>
                  <a:lumOff val="40000"/>
                </a:schemeClr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>
                <a:off x="1608897" y="4581888"/>
                <a:ext cx="1215931" cy="707886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Loading Diluted libraries on to the </a:t>
                </a:r>
                <a:r>
                  <a:rPr lang="en-US" sz="1000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iSeq</a:t>
                </a:r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for Sequencing run</a:t>
                </a:r>
              </a:p>
            </p:txBody>
          </p:sp>
        </p:grpSp>
        <p:grpSp>
          <p:nvGrpSpPr>
            <p:cNvPr id="40" name="Group 39"/>
            <p:cNvGrpSpPr/>
            <p:nvPr/>
          </p:nvGrpSpPr>
          <p:grpSpPr>
            <a:xfrm>
              <a:off x="6008201" y="4057631"/>
              <a:ext cx="1441554" cy="1429789"/>
              <a:chOff x="1583961" y="4206239"/>
              <a:chExt cx="1441554" cy="1429789"/>
            </a:xfrm>
            <a:solidFill>
              <a:schemeClr val="accent1">
                <a:lumMod val="60000"/>
                <a:lumOff val="40000"/>
              </a:schemeClr>
            </a:solidFill>
          </p:grpSpPr>
          <p:sp>
            <p:nvSpPr>
              <p:cNvPr id="41" name="Right Arrow 40"/>
              <p:cNvSpPr/>
              <p:nvPr/>
            </p:nvSpPr>
            <p:spPr>
              <a:xfrm>
                <a:off x="1583961" y="4206239"/>
                <a:ext cx="1441554" cy="1429789"/>
              </a:xfrm>
              <a:prstGeom prst="rightArrow">
                <a:avLst/>
              </a:prstGeom>
              <a:grpFill/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000" dirty="0">
                  <a:solidFill>
                    <a:schemeClr val="tx1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1608898" y="4648392"/>
                <a:ext cx="1032937" cy="55399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000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ata analysis, interpretation and reporting</a:t>
                </a:r>
              </a:p>
            </p:txBody>
          </p:sp>
        </p:grpSp>
        <p:grpSp>
          <p:nvGrpSpPr>
            <p:cNvPr id="51" name="Group 50"/>
            <p:cNvGrpSpPr/>
            <p:nvPr/>
          </p:nvGrpSpPr>
          <p:grpSpPr>
            <a:xfrm>
              <a:off x="346715" y="5570546"/>
              <a:ext cx="6554661" cy="277000"/>
              <a:chOff x="1762398" y="5879865"/>
              <a:chExt cx="6554661" cy="277000"/>
            </a:xfrm>
          </p:grpSpPr>
          <p:sp>
            <p:nvSpPr>
              <p:cNvPr id="12" name="TextBox 11"/>
              <p:cNvSpPr txBox="1"/>
              <p:nvPr/>
            </p:nvSpPr>
            <p:spPr>
              <a:xfrm>
                <a:off x="1762398" y="5879866"/>
                <a:ext cx="736793" cy="276999"/>
              </a:xfrm>
              <a:prstGeom prst="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0 min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>
                <a:off x="3308358" y="5879866"/>
                <a:ext cx="736793" cy="276999"/>
              </a:xfrm>
              <a:prstGeom prst="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rs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>
                <a:off x="4690622" y="5879866"/>
                <a:ext cx="736793" cy="276999"/>
              </a:xfrm>
              <a:prstGeom prst="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rs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6072886" y="5879866"/>
                <a:ext cx="736793" cy="276999"/>
              </a:xfrm>
              <a:prstGeom prst="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7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rs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7580266" y="5879865"/>
                <a:ext cx="736793" cy="276999"/>
              </a:xfrm>
              <a:prstGeom prst="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 </a:t>
                </a:r>
                <a:r>
                  <a:rPr lang="en-US" sz="1200" b="1" dirty="0" err="1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hr</a:t>
                </a:r>
                <a:endParaRPr lang="en-US" sz="1200" b="1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7" name="Straight Arrow Connector 46"/>
              <p:cNvCxnSpPr/>
              <p:nvPr/>
            </p:nvCxnSpPr>
            <p:spPr>
              <a:xfrm>
                <a:off x="4086716" y="6012776"/>
                <a:ext cx="54864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8" name="Straight Arrow Connector 47"/>
              <p:cNvCxnSpPr/>
              <p:nvPr/>
            </p:nvCxnSpPr>
            <p:spPr>
              <a:xfrm>
                <a:off x="5477293" y="6012776"/>
                <a:ext cx="54864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Straight Arrow Connector 48"/>
              <p:cNvCxnSpPr/>
              <p:nvPr/>
            </p:nvCxnSpPr>
            <p:spPr>
              <a:xfrm>
                <a:off x="6876183" y="6012776"/>
                <a:ext cx="64547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Straight Arrow Connector 49"/>
              <p:cNvCxnSpPr/>
              <p:nvPr/>
            </p:nvCxnSpPr>
            <p:spPr>
              <a:xfrm>
                <a:off x="2576570" y="6012776"/>
                <a:ext cx="64547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53" name="Group 52"/>
            <p:cNvGrpSpPr/>
            <p:nvPr/>
          </p:nvGrpSpPr>
          <p:grpSpPr>
            <a:xfrm>
              <a:off x="349486" y="3686321"/>
              <a:ext cx="6554661" cy="277000"/>
              <a:chOff x="1762398" y="5879865"/>
              <a:chExt cx="6554661" cy="277000"/>
            </a:xfrm>
          </p:grpSpPr>
          <p:sp>
            <p:nvSpPr>
              <p:cNvPr id="54" name="TextBox 53"/>
              <p:cNvSpPr txBox="1"/>
              <p:nvPr/>
            </p:nvSpPr>
            <p:spPr>
              <a:xfrm>
                <a:off x="1762398" y="5879866"/>
                <a:ext cx="736793" cy="276999"/>
              </a:xfrm>
              <a:prstGeom prst="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ep 1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>
                <a:off x="3308358" y="5879866"/>
                <a:ext cx="736793" cy="276999"/>
              </a:xfrm>
              <a:prstGeom prst="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ep 2</a:t>
                </a: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>
                <a:off x="4690622" y="5879866"/>
                <a:ext cx="736793" cy="276999"/>
              </a:xfrm>
              <a:prstGeom prst="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ep 3</a:t>
                </a:r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6072886" y="5879866"/>
                <a:ext cx="736793" cy="276999"/>
              </a:xfrm>
              <a:prstGeom prst="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ep 4</a:t>
                </a:r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7580266" y="5879865"/>
                <a:ext cx="736793" cy="276999"/>
              </a:xfrm>
              <a:prstGeom prst="rect">
                <a:avLst/>
              </a:prstGeom>
              <a:solidFill>
                <a:schemeClr val="accent3">
                  <a:lumMod val="20000"/>
                  <a:lumOff val="80000"/>
                </a:schemeClr>
              </a:solidFill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b="1" dirty="0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tep 5</a:t>
                </a:r>
              </a:p>
            </p:txBody>
          </p:sp>
          <p:cxnSp>
            <p:nvCxnSpPr>
              <p:cNvPr id="59" name="Straight Arrow Connector 58"/>
              <p:cNvCxnSpPr/>
              <p:nvPr/>
            </p:nvCxnSpPr>
            <p:spPr>
              <a:xfrm>
                <a:off x="4086716" y="6012776"/>
                <a:ext cx="54864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Straight Arrow Connector 59"/>
              <p:cNvCxnSpPr/>
              <p:nvPr/>
            </p:nvCxnSpPr>
            <p:spPr>
              <a:xfrm>
                <a:off x="5477293" y="6012776"/>
                <a:ext cx="548640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Straight Arrow Connector 60"/>
              <p:cNvCxnSpPr/>
              <p:nvPr/>
            </p:nvCxnSpPr>
            <p:spPr>
              <a:xfrm>
                <a:off x="6876183" y="6012776"/>
                <a:ext cx="64547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Straight Arrow Connector 61"/>
              <p:cNvCxnSpPr/>
              <p:nvPr/>
            </p:nvCxnSpPr>
            <p:spPr>
              <a:xfrm>
                <a:off x="2576570" y="6012776"/>
                <a:ext cx="645471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triangle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66" name="Rectangle 65"/>
          <p:cNvSpPr/>
          <p:nvPr/>
        </p:nvSpPr>
        <p:spPr>
          <a:xfrm>
            <a:off x="143339" y="714939"/>
            <a:ext cx="7196799" cy="25334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7" name="Rectangle 66"/>
          <p:cNvSpPr/>
          <p:nvPr/>
        </p:nvSpPr>
        <p:spPr>
          <a:xfrm>
            <a:off x="130549" y="3653152"/>
            <a:ext cx="7209589" cy="301366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68" name="Rectangle 67"/>
          <p:cNvSpPr/>
          <p:nvPr/>
        </p:nvSpPr>
        <p:spPr>
          <a:xfrm>
            <a:off x="7444737" y="714623"/>
            <a:ext cx="4544350" cy="5952183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1" name="Rectangle: Rounded Corners 7">
            <a:extLst>
              <a:ext uri="{FF2B5EF4-FFF2-40B4-BE49-F238E27FC236}">
                <a16:creationId xmlns:a16="http://schemas.microsoft.com/office/drawing/2014/main" id="{957DCC24-A3EE-1B77-FC8E-ED0316060F6B}"/>
              </a:ext>
            </a:extLst>
          </p:cNvPr>
          <p:cNvSpPr/>
          <p:nvPr/>
        </p:nvSpPr>
        <p:spPr>
          <a:xfrm>
            <a:off x="6031744" y="1026984"/>
            <a:ext cx="1005840" cy="548640"/>
          </a:xfrm>
          <a:prstGeom prst="roundRect">
            <a:avLst/>
          </a:prstGeom>
          <a:solidFill>
            <a:schemeClr val="accent6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CA" sz="1000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roficiency Testing (n=10)</a:t>
            </a:r>
          </a:p>
        </p:txBody>
      </p:sp>
      <p:pic>
        <p:nvPicPr>
          <p:cNvPr id="64" name="Picture 63"/>
          <p:cNvPicPr/>
          <p:nvPr/>
        </p:nvPicPr>
        <p:blipFill rotWithShape="1">
          <a:blip r:embed="rId2"/>
          <a:srcRect b="22870"/>
          <a:stretch/>
        </p:blipFill>
        <p:spPr bwMode="auto">
          <a:xfrm>
            <a:off x="7522922" y="805934"/>
            <a:ext cx="4423772" cy="16981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pic>
        <p:nvPicPr>
          <p:cNvPr id="17" name="Picture 16"/>
          <p:cNvPicPr>
            <a:picLocks noChangeAspect="1"/>
          </p:cNvPicPr>
          <p:nvPr/>
        </p:nvPicPr>
        <p:blipFill rotWithShape="1">
          <a:blip r:embed="rId3"/>
          <a:srcRect b="9447"/>
          <a:stretch/>
        </p:blipFill>
        <p:spPr>
          <a:xfrm>
            <a:off x="7751416" y="2721368"/>
            <a:ext cx="4170598" cy="3414349"/>
          </a:xfrm>
          <a:prstGeom prst="rect">
            <a:avLst/>
          </a:prstGeom>
        </p:spPr>
      </p:pic>
      <p:sp>
        <p:nvSpPr>
          <p:cNvPr id="72" name="Rectangle 73"/>
          <p:cNvSpPr>
            <a:spLocks noChangeArrowheads="1"/>
          </p:cNvSpPr>
          <p:nvPr/>
        </p:nvSpPr>
        <p:spPr bwMode="auto">
          <a:xfrm>
            <a:off x="8774177" y="917683"/>
            <a:ext cx="260862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alt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NP distribution across the genome</a:t>
            </a:r>
          </a:p>
        </p:txBody>
      </p:sp>
      <p:sp>
        <p:nvSpPr>
          <p:cNvPr id="73" name="Rectangle 73"/>
          <p:cNvSpPr>
            <a:spLocks noChangeArrowheads="1"/>
          </p:cNvSpPr>
          <p:nvPr/>
        </p:nvSpPr>
        <p:spPr bwMode="auto">
          <a:xfrm>
            <a:off x="7462762" y="6335873"/>
            <a:ext cx="3273433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/>
          <a:p>
            <a:pPr algn="just">
              <a:defRPr/>
            </a:pPr>
            <a:r>
              <a:rPr lang="en-US" altLang="en-US" sz="1200" b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US" alt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US" alt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lloSeq</a:t>
            </a:r>
            <a:r>
              <a:rPr lang="en-US" alt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HCT library preparation workflow </a:t>
            </a: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1E318FB1-8F95-5DE0-BBD3-9E8C93A516C3}"/>
              </a:ext>
            </a:extLst>
          </p:cNvPr>
          <p:cNvSpPr txBox="1"/>
          <p:nvPr/>
        </p:nvSpPr>
        <p:spPr>
          <a:xfrm>
            <a:off x="143339" y="235575"/>
            <a:ext cx="1183900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S1: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 overview of DNA samples included in the NGS based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chimerism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alidation process and </a:t>
            </a:r>
            <a:r>
              <a:rPr lang="en-US" sz="14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lloSeq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HCT library preparation workflow </a:t>
            </a:r>
          </a:p>
        </p:txBody>
      </p:sp>
    </p:spTree>
    <p:extLst>
      <p:ext uri="{BB962C8B-B14F-4D97-AF65-F5344CB8AC3E}">
        <p14:creationId xmlns:p14="http://schemas.microsoft.com/office/powerpoint/2010/main" val="5639489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633</TotalTime>
  <Words>217</Words>
  <Application>Microsoft Office PowerPoint</Application>
  <PresentationFormat>Widescreen</PresentationFormat>
  <Paragraphs>2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Gaurav Tripathi</dc:creator>
  <cp:lastModifiedBy>MDPI</cp:lastModifiedBy>
  <cp:revision>68</cp:revision>
  <dcterms:created xsi:type="dcterms:W3CDTF">2022-12-22T03:49:31Z</dcterms:created>
  <dcterms:modified xsi:type="dcterms:W3CDTF">2023-07-23T01:01:24Z</dcterms:modified>
</cp:coreProperties>
</file>